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compatMode="1" saveSubsetFonts="1" autoCompressPictures="0">
  <p:sldMasterIdLst>
    <p:sldMasterId id="2147483660" r:id="rId1"/>
  </p:sldMasterIdLst>
  <p:notesMasterIdLst>
    <p:notesMasterId r:id="rId3"/>
  </p:notesMasterIdLst>
  <p:sldIdLst>
    <p:sldId id="283" r:id="rId2"/>
  </p:sldIdLst>
  <p:sldSz cx="6858000" cy="9906000" type="A4"/>
  <p:notesSz cx="6858000" cy="9144000"/>
  <p:defaultTextStyle>
    <a:defPPr>
      <a:defRPr lang="en-US"/>
    </a:defPPr>
    <a:lvl1pPr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1pPr>
    <a:lvl2pPr marL="4572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2pPr>
    <a:lvl3pPr marL="9144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3pPr>
    <a:lvl4pPr marL="13716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4pPr>
    <a:lvl5pPr marL="18288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2DE63D5-997A-4646-A377-4702673A728D}" styleName="Light Style 2 – Acc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69C7853C-536D-4A76-A0AE-DD22124D55A5}" styleName="Themed Style 1 –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473" autoAdjust="0"/>
    <p:restoredTop sz="94384" autoAdjust="0"/>
  </p:normalViewPr>
  <p:slideViewPr>
    <p:cSldViewPr snapToGrid="0">
      <p:cViewPr varScale="1">
        <p:scale>
          <a:sx n="84" d="100"/>
          <a:sy n="84" d="100"/>
        </p:scale>
        <p:origin x="3848" y="184"/>
      </p:cViewPr>
      <p:guideLst/>
    </p:cSldViewPr>
  </p:slideViewPr>
  <p:notesTextViewPr>
    <p:cViewPr>
      <p:scale>
        <a:sx n="75" d="100"/>
        <a:sy n="7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A426E377-15E9-BE92-2901-41B2A79A2239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E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63D6F54-8B5C-57F5-E28F-213F6BA13597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</a:defRPr>
            </a:lvl1pPr>
          </a:lstStyle>
          <a:p>
            <a:pPr>
              <a:defRPr/>
            </a:pPr>
            <a:fld id="{515071CF-6D2D-6647-BB59-84076EBC05A2}" type="datetimeFigureOut">
              <a:rPr lang="en-ES"/>
              <a:pPr>
                <a:defRPr/>
              </a:pPr>
              <a:t>18/6/25</a:t>
            </a:fld>
            <a:endParaRPr lang="en-ES"/>
          </a:p>
        </p:txBody>
      </p:sp>
      <p:sp>
        <p:nvSpPr>
          <p:cNvPr id="4" name="Slide Image Placeholder 3">
            <a:extLst>
              <a:ext uri="{FF2B5EF4-FFF2-40B4-BE49-F238E27FC236}">
                <a16:creationId xmlns:a16="http://schemas.microsoft.com/office/drawing/2014/main" id="{DFE9D6FA-DBA0-9F60-6D56-3909B54DA469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ES" noProof="0"/>
          </a:p>
        </p:txBody>
      </p:sp>
      <p:sp>
        <p:nvSpPr>
          <p:cNvPr id="5" name="Notes Placeholder 4">
            <a:extLst>
              <a:ext uri="{FF2B5EF4-FFF2-40B4-BE49-F238E27FC236}">
                <a16:creationId xmlns:a16="http://schemas.microsoft.com/office/drawing/2014/main" id="{EC1366A2-B272-54DA-D7A3-7D58093E759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 noProof="0"/>
              <a:t>Click to edit Master text styles</a:t>
            </a:r>
          </a:p>
          <a:p>
            <a:pPr lvl="1"/>
            <a:r>
              <a:rPr lang="en-GB" noProof="0"/>
              <a:t>Second level</a:t>
            </a:r>
          </a:p>
          <a:p>
            <a:pPr lvl="2"/>
            <a:r>
              <a:rPr lang="en-GB" noProof="0"/>
              <a:t>Third level</a:t>
            </a:r>
          </a:p>
          <a:p>
            <a:pPr lvl="3"/>
            <a:r>
              <a:rPr lang="en-GB" noProof="0"/>
              <a:t>Fourth level</a:t>
            </a:r>
          </a:p>
          <a:p>
            <a:pPr lvl="4"/>
            <a:r>
              <a:rPr lang="en-GB" noProof="0"/>
              <a:t>Fifth level</a:t>
            </a:r>
            <a:endParaRPr lang="en-ES" noProof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372E18F-4995-423B-834E-AB9F74042357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E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E4CB2FB-9D08-B86F-4167-9F13B0818409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</a:defRPr>
            </a:lvl1pPr>
          </a:lstStyle>
          <a:p>
            <a:pPr>
              <a:defRPr/>
            </a:pPr>
            <a:fld id="{A6D711A8-2A35-C74F-9F2E-92C27FCF1D07}" type="slidenum">
              <a:rPr lang="en-ES"/>
              <a:pPr>
                <a:defRPr/>
              </a:pPr>
              <a:t>‹#›</a:t>
            </a:fld>
            <a:endParaRPr lang="en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6143E7-1F92-3B72-8837-108E5866B0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A93A9CD-D7E0-0F4A-B258-3A785360445E}" type="datetimeFigureOut">
              <a:rPr lang="en-ES"/>
              <a:pPr>
                <a:defRPr/>
              </a:pPr>
              <a:t>18/6/25</a:t>
            </a:fld>
            <a:endParaRPr lang="en-E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EDF6B5-2A99-9578-1618-0F29103463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E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9EA3BB-B5B2-C9CD-98D3-F38543717C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4F0A64F-82EF-0145-A862-618043A1477D}" type="slidenum">
              <a:rPr lang="en-ES"/>
              <a:pPr>
                <a:defRPr/>
              </a:pPr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5454596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CDCAD8-A71E-B783-DD69-40E44B2996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5F7CEA3-5EAF-C045-BD45-CA4505CD9169}" type="datetimeFigureOut">
              <a:rPr lang="en-ES"/>
              <a:pPr>
                <a:defRPr/>
              </a:pPr>
              <a:t>18/6/25</a:t>
            </a:fld>
            <a:endParaRPr lang="en-E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539F1D-4A16-36CD-F822-076AFE1B03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E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DA4FF0-E742-FCD6-5F8E-1D867A72F2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5E761C6-278D-E34A-9C86-6EB71552F80E}" type="slidenum">
              <a:rPr lang="en-ES"/>
              <a:pPr>
                <a:defRPr/>
              </a:pPr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36735874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DA1B92-7A8B-4A64-B943-F433030008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2025578-E0F5-8447-97E9-577D5275B41F}" type="datetimeFigureOut">
              <a:rPr lang="en-ES"/>
              <a:pPr>
                <a:defRPr/>
              </a:pPr>
              <a:t>18/6/25</a:t>
            </a:fld>
            <a:endParaRPr lang="en-E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4B2470-EE3F-83FF-E778-1CFB11AB87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E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838C20-0D36-2C3C-6028-60D9527212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C368770-1387-794D-8319-10AE67E72A01}" type="slidenum">
              <a:rPr lang="en-ES"/>
              <a:pPr>
                <a:defRPr/>
              </a:pPr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36770288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27E72B-2DE5-A9E1-4D47-CC80C69883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E8672E2-1D11-9D43-9BCF-CFDE80505716}" type="datetimeFigureOut">
              <a:rPr lang="en-ES"/>
              <a:pPr>
                <a:defRPr/>
              </a:pPr>
              <a:t>18/6/25</a:t>
            </a:fld>
            <a:endParaRPr lang="en-E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15F9E6-5673-FC49-6322-F9A772C4B1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E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EAB8C8-F9E7-7831-2245-E6241C9965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32BCB06-F0F7-3348-A1FD-703316107FC4}" type="slidenum">
              <a:rPr lang="en-ES"/>
              <a:pPr>
                <a:defRPr/>
              </a:pPr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42606635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5FAA97-31A2-C7E8-4502-6D640845EE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FEEBBF2-0957-9947-A11F-3C687CCE6442}" type="datetimeFigureOut">
              <a:rPr lang="en-ES"/>
              <a:pPr>
                <a:defRPr/>
              </a:pPr>
              <a:t>18/6/25</a:t>
            </a:fld>
            <a:endParaRPr lang="en-E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BC3E64-4F9F-7DD9-701C-3242046B3B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E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40C1E5-096A-2B50-AB72-FE71027B31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2C580CA-53A7-0246-A73F-5770094D2BDE}" type="slidenum">
              <a:rPr lang="en-ES"/>
              <a:pPr>
                <a:defRPr/>
              </a:pPr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0241426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ABD9647A-4B52-CE23-F9E9-A82FDC3BBA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2E28D01-59B4-714B-B33F-D8E598611338}" type="datetimeFigureOut">
              <a:rPr lang="en-ES"/>
              <a:pPr>
                <a:defRPr/>
              </a:pPr>
              <a:t>18/6/25</a:t>
            </a:fld>
            <a:endParaRPr lang="en-E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BC4D246C-2FAE-E99E-EDA9-E5F80F9164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E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1DDC3CFF-1EEA-C570-4239-5C9D3496C1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D169ABF-3F64-AF42-AB2E-D9134BF0204C}" type="slidenum">
              <a:rPr lang="en-ES"/>
              <a:pPr>
                <a:defRPr/>
              </a:pPr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3575840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BF9B590B-4BAA-FB6A-3ACB-FDFF94534D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835D5BB-84E1-674D-8D61-519BC8D213AE}" type="datetimeFigureOut">
              <a:rPr lang="en-ES"/>
              <a:pPr>
                <a:defRPr/>
              </a:pPr>
              <a:t>18/6/25</a:t>
            </a:fld>
            <a:endParaRPr lang="en-ES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AD8B2BB3-F248-F2EC-614B-07C4498E65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ES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3D059903-D4EA-3285-4FDA-82FA6BA1AC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C85FEA3-C281-B34E-854B-C1A989977538}" type="slidenum">
              <a:rPr lang="en-ES"/>
              <a:pPr>
                <a:defRPr/>
              </a:pPr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31234850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7D40D278-4F3F-805E-A697-2B90F86110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832B08-5BDC-1A4A-A4F7-98D501052EBB}" type="datetimeFigureOut">
              <a:rPr lang="en-ES"/>
              <a:pPr>
                <a:defRPr/>
              </a:pPr>
              <a:t>18/6/25</a:t>
            </a:fld>
            <a:endParaRPr lang="en-ES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9CC586B6-8C1D-664D-B167-28A18DEEB9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ES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DBF48747-B54E-80A9-E1D4-1F7B893051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6CF178F-8DB3-F742-B72C-1C8CA6CB8AA3}" type="slidenum">
              <a:rPr lang="en-ES"/>
              <a:pPr>
                <a:defRPr/>
              </a:pPr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5271324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8FE1B42F-3F95-42EA-310C-77A06C9A1F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303A386-DCDB-9147-8A8E-8240BDD5AEAD}" type="datetimeFigureOut">
              <a:rPr lang="en-ES"/>
              <a:pPr>
                <a:defRPr/>
              </a:pPr>
              <a:t>18/6/25</a:t>
            </a:fld>
            <a:endParaRPr lang="en-ES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256E2C09-631A-8201-5827-C6AD240CA8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ES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0A56F5EA-A976-BA20-15F0-8CADDB41C1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50CA07-937F-7044-9065-4E607ABD524E}" type="slidenum">
              <a:rPr lang="en-ES"/>
              <a:pPr>
                <a:defRPr/>
              </a:pPr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3083220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AD496318-A02D-099B-A582-5A0653544E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8D9D343-5468-9746-B901-1F1B91620C62}" type="datetimeFigureOut">
              <a:rPr lang="en-ES"/>
              <a:pPr>
                <a:defRPr/>
              </a:pPr>
              <a:t>18/6/25</a:t>
            </a:fld>
            <a:endParaRPr lang="en-E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F7149F10-92EA-54E6-4EE9-E4CE366291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E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1EDF1B84-FBC2-CE7F-80AC-71D728FC3A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D4013E-2522-F044-81B3-1D9FCF684E3B}" type="slidenum">
              <a:rPr lang="en-ES"/>
              <a:pPr>
                <a:defRPr/>
              </a:pPr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1911430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lvl="0"/>
            <a:r>
              <a:rPr lang="en-GB" noProof="0" dirty="0"/>
              <a:t>Click icon to add picture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78E23019-D55D-B466-B797-C44F8F50A5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903A95B-5A95-714F-A525-50618D2102D8}" type="datetimeFigureOut">
              <a:rPr lang="en-ES"/>
              <a:pPr>
                <a:defRPr/>
              </a:pPr>
              <a:t>18/6/25</a:t>
            </a:fld>
            <a:endParaRPr lang="en-E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4E0D1CAF-6594-5C16-682F-B6B1BBA916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E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333BA585-B685-58EC-6D29-2517EAF33F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03BD30-DB16-3148-AD2B-C8C8AF625C55}" type="slidenum">
              <a:rPr lang="en-ES"/>
              <a:pPr>
                <a:defRPr/>
              </a:pPr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3704230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>
            <a:extLst>
              <a:ext uri="{FF2B5EF4-FFF2-40B4-BE49-F238E27FC236}">
                <a16:creationId xmlns:a16="http://schemas.microsoft.com/office/drawing/2014/main" id="{C60A03EE-61BC-F635-A215-1F3B2E8CABB3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471488" y="527050"/>
            <a:ext cx="5915025" cy="1914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GB" altLang="en-ES"/>
              <a:t>Click to edit Master title style</a:t>
            </a:r>
            <a:endParaRPr lang="en-US" altLang="en-E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F2A2B1C-B85D-4938-22CE-609B3467F0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6838"/>
            <a:ext cx="5915025" cy="62849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CBD56C-E1D5-9C6C-145F-F1A5E2AB227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2100"/>
            <a:ext cx="154305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9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9AB19780-1CA6-C548-9BF8-2FF4CA16ACA3}" type="datetimeFigureOut">
              <a:rPr lang="en-ES"/>
              <a:pPr>
                <a:defRPr/>
              </a:pPr>
              <a:t>18/6/25</a:t>
            </a:fld>
            <a:endParaRPr lang="en-E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84CE73-1E99-C03E-28EE-E23EC20242B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2100"/>
            <a:ext cx="2314575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E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0C83B6-4182-5C4A-246A-C0937ED0DC0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2100"/>
            <a:ext cx="154305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9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1C7F392B-0077-9E4C-B2BA-8356C3A8D503}" type="slidenum">
              <a:rPr lang="en-ES"/>
              <a:pPr>
                <a:defRPr/>
              </a:pPr>
              <a:t>‹#›</a:t>
            </a:fld>
            <a:endParaRPr lang="en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  <a:lvl2pPr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2pPr>
      <a:lvl3pPr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3pPr>
      <a:lvl4pPr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4pPr>
      <a:lvl5pPr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5pPr>
      <a:lvl6pPr marL="4572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6pPr>
      <a:lvl7pPr marL="9144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7pPr>
      <a:lvl8pPr marL="13716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8pPr>
      <a:lvl9pPr marL="18288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9pPr>
    </p:titleStyle>
    <p:bodyStyle>
      <a:lvl1pPr marL="171450" indent="-171450" algn="l" defTabSz="685800" rtl="0" fontAlgn="base">
        <a:lnSpc>
          <a:spcPct val="90000"/>
        </a:lnSpc>
        <a:spcBef>
          <a:spcPts val="750"/>
        </a:spcBef>
        <a:spcAft>
          <a:spcPct val="0"/>
        </a:spcAft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fontAlgn="base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fontAlgn="base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fontAlgn="base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fontAlgn="base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03769104-7BB0-7899-8F93-232FE934B333}"/>
              </a:ext>
            </a:extLst>
          </p:cNvPr>
          <p:cNvGraphicFramePr>
            <a:graphicFrameLocks noGrp="1"/>
          </p:cNvGraphicFramePr>
          <p:nvPr/>
        </p:nvGraphicFramePr>
        <p:xfrm>
          <a:off x="512763" y="449263"/>
          <a:ext cx="5832477" cy="3379794"/>
        </p:xfrm>
        <a:graphic>
          <a:graphicData uri="http://schemas.openxmlformats.org/drawingml/2006/table">
            <a:tbl>
              <a:tblPr firstRow="1" bandRow="1"/>
              <a:tblGrid>
                <a:gridCol w="72005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2005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2005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7604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57604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648053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648053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576047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648053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324114">
                <a:tc gridSpan="9">
                  <a:txBody>
                    <a:bodyPr/>
                    <a:lstStyle/>
                    <a:p>
                      <a:pPr algn="l"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1 Table — </a:t>
                      </a:r>
                      <a:r>
                        <a:rPr lang="en-US" sz="1200" b="1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gAse</a:t>
                      </a: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constructs assayed.</a:t>
                      </a:r>
                    </a:p>
                  </a:txBody>
                  <a:tcPr marL="18001" marR="18001" marT="18006" marB="180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US" sz="11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8000" marR="18000" marT="18000" marB="1800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US" sz="11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8000" marR="18000" marT="18000" marB="1800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US" sz="11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8000" marR="18000" marT="18000" marB="18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US" sz="11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8000" marR="18000" marT="18000" marB="18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US" sz="11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8000" marR="18000" marT="18000" marB="18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03712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nstruct</a:t>
                      </a:r>
                      <a:endParaRPr lang="en-US" sz="11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8001" marR="18001" marT="18006" marB="180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loned</a:t>
                      </a:r>
                      <a:endParaRPr lang="en-US" sz="11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8001" marR="18001" marT="18006" marB="180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xpressed</a:t>
                      </a:r>
                      <a:endParaRPr lang="en-US" sz="11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8001" marR="18001" marT="18006" marB="180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urified</a:t>
                      </a:r>
                      <a:endParaRPr lang="en-US" sz="11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8001" marR="18001" marT="18006" marB="1800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rystallography</a:t>
                      </a:r>
                      <a:endParaRPr lang="en-US" sz="11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8001" marR="18001" marT="18006" marB="1800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ryo-EM</a:t>
                      </a:r>
                    </a:p>
                  </a:txBody>
                  <a:tcPr marL="18001" marR="18001" marT="18006" marB="1800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US" sz="11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0" marR="18000" marT="18000" marB="18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03712"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US" sz="11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8000" marR="18000" marT="18000" marB="18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US" sz="11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8000" marR="18000" marT="18000" marB="1800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US" sz="11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8000" marR="18000" marT="18000" marB="18000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MAC</a:t>
                      </a:r>
                      <a:endParaRPr lang="en-US" sz="11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8001" marR="18001" marT="18006" marB="1800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C</a:t>
                      </a:r>
                      <a:endParaRPr lang="en-US" sz="11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rystals</a:t>
                      </a:r>
                      <a:endParaRPr lang="en-US" sz="11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8001" marR="18001" marT="18006" marB="1800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tructure</a:t>
                      </a:r>
                      <a:endParaRPr lang="en-US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8001" marR="18001" marT="18006" marB="18006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0" lang="en-US" sz="11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rids</a:t>
                      </a:r>
                      <a:endParaRPr lang="en-US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8001" marR="18001" marT="18006" marB="18006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ucture</a:t>
                      </a:r>
                    </a:p>
                  </a:txBody>
                  <a:tcPr marL="18001" marR="18001" marT="18006" marB="18006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0371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</a:t>
                      </a:r>
                      <a:endParaRPr lang="en-US" sz="11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0" kern="1200" dirty="0">
                          <a:solidFill>
                            <a:srgbClr val="000000"/>
                          </a:solidFill>
                          <a:effectLst/>
                          <a:latin typeface="Segoe UI Symbol" panose="020B0502040204020203" pitchFamily="34" charset="0"/>
                          <a:ea typeface="Times New Roman" panose="02020603050405020304" pitchFamily="18" charset="0"/>
                          <a:cs typeface="Segoe UI Symbol" panose="020B0502040204020203" pitchFamily="34" charset="0"/>
                        </a:rPr>
                        <a:t>✓</a:t>
                      </a:r>
                      <a:endParaRPr lang="en-US" sz="11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Segoe UI Symbol" panose="020B0502040204020203" pitchFamily="34" charset="0"/>
                          <a:ea typeface="Times New Roman" panose="02020603050405020304" pitchFamily="18" charset="0"/>
                          <a:cs typeface="Segoe UI Symbol" panose="020B0502040204020203" pitchFamily="34" charset="0"/>
                        </a:rPr>
                        <a:t>✓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Segoe UI Symbol" panose="020B0502040204020203" pitchFamily="34" charset="0"/>
                          <a:ea typeface="Times New Roman" panose="02020603050405020304" pitchFamily="18" charset="0"/>
                          <a:cs typeface="Segoe UI Symbol" panose="020B0502040204020203" pitchFamily="34" charset="0"/>
                        </a:rPr>
                        <a:t>✓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Segoe UI Symbol" panose="020B0502040204020203" pitchFamily="34" charset="0"/>
                          <a:ea typeface="Times New Roman" panose="02020603050405020304" pitchFamily="18" charset="0"/>
                          <a:cs typeface="Segoe UI Symbol" panose="020B0502040204020203" pitchFamily="34" charset="0"/>
                        </a:rPr>
                        <a:t>✓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Segoe UI Symbol" panose="020B0502040204020203" pitchFamily="34" charset="0"/>
                          <a:ea typeface="Times New Roman" panose="02020603050405020304" pitchFamily="18" charset="0"/>
                          <a:cs typeface="Segoe UI Symbol" panose="020B0502040204020203" pitchFamily="34" charset="0"/>
                        </a:rPr>
                        <a:t>✓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x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-</a:t>
                      </a:r>
                    </a:p>
                  </a:txBody>
                  <a:tcPr marL="18001" marR="18001" marT="18006" marB="18006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-</a:t>
                      </a:r>
                    </a:p>
                  </a:txBody>
                  <a:tcPr marL="18001" marR="18001" marT="18006" marB="18006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0371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-2</a:t>
                      </a:r>
                      <a:endParaRPr lang="en-US" sz="11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0" kern="1200" dirty="0">
                          <a:solidFill>
                            <a:srgbClr val="000000"/>
                          </a:solidFill>
                          <a:effectLst/>
                          <a:latin typeface="Segoe UI Symbol" panose="020B0502040204020203" pitchFamily="34" charset="0"/>
                          <a:ea typeface="Times New Roman" panose="02020603050405020304" pitchFamily="18" charset="0"/>
                          <a:cs typeface="Segoe UI Symbol" panose="020B0502040204020203" pitchFamily="34" charset="0"/>
                        </a:rPr>
                        <a:t>✓</a:t>
                      </a:r>
                      <a:endParaRPr lang="en-US" sz="11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Segoe UI Symbol" panose="020B0502040204020203" pitchFamily="34" charset="0"/>
                          <a:ea typeface="Times New Roman" panose="02020603050405020304" pitchFamily="18" charset="0"/>
                          <a:cs typeface="Segoe UI Symbol" panose="020B0502040204020203" pitchFamily="34" charset="0"/>
                        </a:rPr>
                        <a:t>✓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Segoe UI Symbol" panose="020B0502040204020203" pitchFamily="34" charset="0"/>
                          <a:ea typeface="Times New Roman" panose="02020603050405020304" pitchFamily="18" charset="0"/>
                          <a:cs typeface="Segoe UI Symbol" panose="020B0502040204020203" pitchFamily="34" charset="0"/>
                        </a:rPr>
                        <a:t>✓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x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-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-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-</a:t>
                      </a:r>
                    </a:p>
                  </a:txBody>
                  <a:tcPr marL="18001" marR="18001" marT="18006" marB="18006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-</a:t>
                      </a:r>
                    </a:p>
                  </a:txBody>
                  <a:tcPr marL="18001" marR="18001" marT="18006" marB="18006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0371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-3</a:t>
                      </a:r>
                      <a:endParaRPr lang="en-US" sz="11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0" kern="1200" dirty="0">
                          <a:solidFill>
                            <a:srgbClr val="000000"/>
                          </a:solidFill>
                          <a:effectLst/>
                          <a:latin typeface="Segoe UI Symbol" panose="020B0502040204020203" pitchFamily="34" charset="0"/>
                          <a:ea typeface="Times New Roman" panose="02020603050405020304" pitchFamily="18" charset="0"/>
                          <a:cs typeface="Segoe UI Symbol" panose="020B0502040204020203" pitchFamily="34" charset="0"/>
                        </a:rPr>
                        <a:t>✓</a:t>
                      </a:r>
                      <a:endParaRPr lang="en-US" sz="11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Segoe UI Symbol" panose="020B0502040204020203" pitchFamily="34" charset="0"/>
                          <a:ea typeface="Times New Roman" panose="02020603050405020304" pitchFamily="18" charset="0"/>
                          <a:cs typeface="Segoe UI Symbol" panose="020B0502040204020203" pitchFamily="34" charset="0"/>
                        </a:rPr>
                        <a:t>✓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Segoe UI Symbol" panose="020B0502040204020203" pitchFamily="34" charset="0"/>
                          <a:ea typeface="Times New Roman" panose="02020603050405020304" pitchFamily="18" charset="0"/>
                          <a:cs typeface="Segoe UI Symbol" panose="020B0502040204020203" pitchFamily="34" charset="0"/>
                        </a:rPr>
                        <a:t>✓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Segoe UI Symbol" panose="020B0502040204020203" pitchFamily="34" charset="0"/>
                          <a:ea typeface="Times New Roman" panose="02020603050405020304" pitchFamily="18" charset="0"/>
                          <a:cs typeface="Segoe UI Symbol" panose="020B0502040204020203" pitchFamily="34" charset="0"/>
                        </a:rPr>
                        <a:t>✓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Segoe UI Symbol" panose="020B0502040204020203" pitchFamily="34" charset="0"/>
                          <a:ea typeface="Times New Roman" panose="02020603050405020304" pitchFamily="18" charset="0"/>
                          <a:cs typeface="Segoe UI Symbol" panose="020B0502040204020203" pitchFamily="34" charset="0"/>
                        </a:rPr>
                        <a:t>✓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x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-</a:t>
                      </a:r>
                    </a:p>
                  </a:txBody>
                  <a:tcPr marL="18001" marR="18001" marT="18006" marB="18006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-</a:t>
                      </a:r>
                    </a:p>
                  </a:txBody>
                  <a:tcPr marL="18001" marR="18001" marT="18006" marB="18006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0371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-4</a:t>
                      </a:r>
                      <a:endParaRPr lang="en-US" sz="11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0" kern="1200" dirty="0">
                          <a:solidFill>
                            <a:srgbClr val="000000"/>
                          </a:solidFill>
                          <a:effectLst/>
                          <a:latin typeface="Segoe UI Symbol" panose="020B0502040204020203" pitchFamily="34" charset="0"/>
                          <a:ea typeface="Times New Roman" panose="02020603050405020304" pitchFamily="18" charset="0"/>
                          <a:cs typeface="Segoe UI Symbol" panose="020B0502040204020203" pitchFamily="34" charset="0"/>
                        </a:rPr>
                        <a:t>✓</a:t>
                      </a:r>
                      <a:endParaRPr lang="en-US" sz="11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Segoe UI Symbol" panose="020B0502040204020203" pitchFamily="34" charset="0"/>
                          <a:ea typeface="Times New Roman" panose="02020603050405020304" pitchFamily="18" charset="0"/>
                          <a:cs typeface="Segoe UI Symbol" panose="020B0502040204020203" pitchFamily="34" charset="0"/>
                        </a:rPr>
                        <a:t>✓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Segoe UI Symbol" panose="020B0502040204020203" pitchFamily="34" charset="0"/>
                          <a:ea typeface="Times New Roman" panose="02020603050405020304" pitchFamily="18" charset="0"/>
                          <a:cs typeface="Segoe UI Symbol" panose="020B0502040204020203" pitchFamily="34" charset="0"/>
                        </a:rPr>
                        <a:t>✓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Segoe UI Symbol" panose="020B0502040204020203" pitchFamily="34" charset="0"/>
                          <a:ea typeface="Times New Roman" panose="02020603050405020304" pitchFamily="18" charset="0"/>
                          <a:cs typeface="Segoe UI Symbol" panose="020B0502040204020203" pitchFamily="34" charset="0"/>
                        </a:rPr>
                        <a:t>✓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x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-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Segoe UI Symbol" panose="020B0502040204020203" pitchFamily="34" charset="0"/>
                          <a:ea typeface="Times New Roman" panose="02020603050405020304" pitchFamily="18" charset="0"/>
                          <a:cs typeface="Segoe UI Symbol" panose="020B0502040204020203" pitchFamily="34" charset="0"/>
                        </a:rPr>
                        <a:t>✓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x</a:t>
                      </a:r>
                    </a:p>
                  </a:txBody>
                  <a:tcPr marL="18001" marR="18001" marT="18006" marB="18006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0371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-7</a:t>
                      </a:r>
                      <a:endParaRPr lang="en-US" sz="11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0" kern="1200" dirty="0">
                          <a:solidFill>
                            <a:schemeClr val="tx1"/>
                          </a:solidFill>
                          <a:effectLst/>
                          <a:latin typeface="Segoe UI Symbol" panose="020B0502040204020203" pitchFamily="34" charset="0"/>
                          <a:ea typeface="Times New Roman" panose="02020603050405020304" pitchFamily="18" charset="0"/>
                          <a:cs typeface="Segoe UI Symbol" panose="020B0502040204020203" pitchFamily="34" charset="0"/>
                        </a:rPr>
                        <a:t>✓</a:t>
                      </a:r>
                      <a:endParaRPr lang="en-US" sz="11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Segoe UI Symbol" panose="020B0502040204020203" pitchFamily="34" charset="0"/>
                          <a:ea typeface="Times New Roman" panose="02020603050405020304" pitchFamily="18" charset="0"/>
                          <a:cs typeface="Segoe UI Symbol" panose="020B0502040204020203" pitchFamily="34" charset="0"/>
                        </a:rPr>
                        <a:t>✓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Segoe UI Symbol" panose="020B0502040204020203" pitchFamily="34" charset="0"/>
                          <a:ea typeface="Times New Roman" panose="02020603050405020304" pitchFamily="18" charset="0"/>
                          <a:cs typeface="Segoe UI Symbol" panose="020B0502040204020203" pitchFamily="34" charset="0"/>
                        </a:rPr>
                        <a:t>✓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Segoe UI Symbol" panose="020B0502040204020203" pitchFamily="34" charset="0"/>
                          <a:ea typeface="Times New Roman" panose="02020603050405020304" pitchFamily="18" charset="0"/>
                          <a:cs typeface="Segoe UI Symbol" panose="020B0502040204020203" pitchFamily="34" charset="0"/>
                        </a:rPr>
                        <a:t>✓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x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-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Segoe UI Symbol" panose="020B0502040204020203" pitchFamily="34" charset="0"/>
                          <a:ea typeface="Times New Roman" panose="02020603050405020304" pitchFamily="18" charset="0"/>
                          <a:cs typeface="Segoe UI Symbol" panose="020B0502040204020203" pitchFamily="34" charset="0"/>
                        </a:rPr>
                        <a:t>✓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u="none" kern="1200" dirty="0">
                          <a:solidFill>
                            <a:schemeClr val="tx1"/>
                          </a:solidFill>
                          <a:effectLst/>
                          <a:latin typeface="Segoe UI Symbol" panose="020B0502040204020203" pitchFamily="34" charset="0"/>
                          <a:ea typeface="Times New Roman" panose="02020603050405020304" pitchFamily="18" charset="0"/>
                          <a:cs typeface="Segoe UI Symbol" panose="020B0502040204020203" pitchFamily="34" charset="0"/>
                        </a:rPr>
                        <a:t>✓ </a:t>
                      </a:r>
                      <a:r>
                        <a:rPr lang="en-US" sz="1400" b="0" u="none" kern="1200" baseline="30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lang="en-US" sz="1400" b="0" u="none" baseline="30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0371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2</a:t>
                      </a:r>
                      <a:endParaRPr lang="en-US" sz="11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0" kern="1200" dirty="0">
                          <a:solidFill>
                            <a:srgbClr val="000000"/>
                          </a:solidFill>
                          <a:effectLst/>
                          <a:latin typeface="Segoe UI Symbol" panose="020B0502040204020203" pitchFamily="34" charset="0"/>
                          <a:ea typeface="Times New Roman" panose="02020603050405020304" pitchFamily="18" charset="0"/>
                          <a:cs typeface="Segoe UI Symbol" panose="020B0502040204020203" pitchFamily="34" charset="0"/>
                        </a:rPr>
                        <a:t>✓</a:t>
                      </a:r>
                      <a:endParaRPr lang="en-US" sz="11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Segoe UI Symbol" panose="020B0502040204020203" pitchFamily="34" charset="0"/>
                          <a:ea typeface="Times New Roman" panose="02020603050405020304" pitchFamily="18" charset="0"/>
                          <a:cs typeface="Segoe UI Symbol" panose="020B0502040204020203" pitchFamily="34" charset="0"/>
                        </a:rPr>
                        <a:t>✓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Segoe UI Symbol" panose="020B0502040204020203" pitchFamily="34" charset="0"/>
                          <a:ea typeface="Times New Roman" panose="02020603050405020304" pitchFamily="18" charset="0"/>
                          <a:cs typeface="Segoe UI Symbol" panose="020B0502040204020203" pitchFamily="34" charset="0"/>
                        </a:rPr>
                        <a:t>✓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x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-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-</a:t>
                      </a:r>
                    </a:p>
                  </a:txBody>
                  <a:tcPr marL="18001" marR="18001" marT="18006" marB="18006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-</a:t>
                      </a:r>
                    </a:p>
                  </a:txBody>
                  <a:tcPr marL="18001" marR="18001" marT="18006" marB="18006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-</a:t>
                      </a:r>
                    </a:p>
                  </a:txBody>
                  <a:tcPr marL="18001" marR="18001" marT="18006" marB="18006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0371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2-4</a:t>
                      </a:r>
                      <a:endParaRPr lang="en-US" sz="11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0" kern="1200" dirty="0">
                          <a:solidFill>
                            <a:schemeClr val="tx1"/>
                          </a:solidFill>
                          <a:effectLst/>
                          <a:latin typeface="Segoe UI Symbol" panose="020B0502040204020203" pitchFamily="34" charset="0"/>
                          <a:ea typeface="Times New Roman" panose="02020603050405020304" pitchFamily="18" charset="0"/>
                          <a:cs typeface="Segoe UI Symbol" panose="020B0502040204020203" pitchFamily="34" charset="0"/>
                        </a:rPr>
                        <a:t>✓</a:t>
                      </a:r>
                      <a:endParaRPr lang="en-US" sz="11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Segoe UI Symbol" panose="020B0502040204020203" pitchFamily="34" charset="0"/>
                          <a:ea typeface="Times New Roman" panose="02020603050405020304" pitchFamily="18" charset="0"/>
                          <a:cs typeface="Segoe UI Symbol" panose="020B0502040204020203" pitchFamily="34" charset="0"/>
                        </a:rPr>
                        <a:t>✓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Segoe UI Symbol" panose="020B0502040204020203" pitchFamily="34" charset="0"/>
                          <a:ea typeface="Times New Roman" panose="02020603050405020304" pitchFamily="18" charset="0"/>
                          <a:cs typeface="Segoe UI Symbol" panose="020B0502040204020203" pitchFamily="34" charset="0"/>
                        </a:rPr>
                        <a:t>✓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Segoe UI Symbol" panose="020B0502040204020203" pitchFamily="34" charset="0"/>
                          <a:ea typeface="Times New Roman" panose="02020603050405020304" pitchFamily="18" charset="0"/>
                          <a:cs typeface="Segoe UI Symbol" panose="020B0502040204020203" pitchFamily="34" charset="0"/>
                        </a:rPr>
                        <a:t>✓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Segoe UI Symbol" panose="020B0502040204020203" pitchFamily="34" charset="0"/>
                          <a:ea typeface="Times New Roman" panose="02020603050405020304" pitchFamily="18" charset="0"/>
                          <a:cs typeface="Segoe UI Symbol" panose="020B0502040204020203" pitchFamily="34" charset="0"/>
                        </a:rPr>
                        <a:t>✓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u="none" kern="1200" dirty="0">
                          <a:solidFill>
                            <a:schemeClr val="tx1"/>
                          </a:solidFill>
                          <a:effectLst/>
                          <a:latin typeface="Segoe UI Symbol" panose="020B0502040204020203" pitchFamily="34" charset="0"/>
                          <a:ea typeface="Times New Roman" panose="02020603050405020304" pitchFamily="18" charset="0"/>
                          <a:cs typeface="Segoe UI Symbol" panose="020B0502040204020203" pitchFamily="34" charset="0"/>
                        </a:rPr>
                        <a:t>✓</a:t>
                      </a:r>
                      <a:endParaRPr lang="en-US" sz="1100" b="1" u="non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-</a:t>
                      </a:r>
                    </a:p>
                  </a:txBody>
                  <a:tcPr marL="18001" marR="18001" marT="18006" marB="18006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-</a:t>
                      </a:r>
                    </a:p>
                  </a:txBody>
                  <a:tcPr marL="18001" marR="18001" marT="18006" marB="18006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0371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2-5</a:t>
                      </a:r>
                      <a:endParaRPr lang="en-US" sz="11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0" kern="1200" dirty="0">
                          <a:solidFill>
                            <a:srgbClr val="000000"/>
                          </a:solidFill>
                          <a:effectLst/>
                          <a:latin typeface="Segoe UI Symbol" panose="020B0502040204020203" pitchFamily="34" charset="0"/>
                          <a:ea typeface="Times New Roman" panose="02020603050405020304" pitchFamily="18" charset="0"/>
                          <a:cs typeface="Segoe UI Symbol" panose="020B0502040204020203" pitchFamily="34" charset="0"/>
                        </a:rPr>
                        <a:t>✓</a:t>
                      </a:r>
                      <a:endParaRPr lang="en-US" sz="11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Segoe UI Symbol" panose="020B0502040204020203" pitchFamily="34" charset="0"/>
                          <a:ea typeface="Times New Roman" panose="02020603050405020304" pitchFamily="18" charset="0"/>
                          <a:cs typeface="Segoe UI Symbol" panose="020B0502040204020203" pitchFamily="34" charset="0"/>
                        </a:rPr>
                        <a:t>✓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Segoe UI Symbol" panose="020B0502040204020203" pitchFamily="34" charset="0"/>
                          <a:ea typeface="Times New Roman" panose="02020603050405020304" pitchFamily="18" charset="0"/>
                          <a:cs typeface="Segoe UI Symbol" panose="020B0502040204020203" pitchFamily="34" charset="0"/>
                        </a:rPr>
                        <a:t>✓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Segoe UI Symbol" panose="020B0502040204020203" pitchFamily="34" charset="0"/>
                          <a:ea typeface="Times New Roman" panose="02020603050405020304" pitchFamily="18" charset="0"/>
                          <a:cs typeface="Segoe UI Symbol" panose="020B0502040204020203" pitchFamily="34" charset="0"/>
                        </a:rPr>
                        <a:t>✓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x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-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-</a:t>
                      </a:r>
                    </a:p>
                  </a:txBody>
                  <a:tcPr marL="18001" marR="18001" marT="18006" marB="18006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-</a:t>
                      </a:r>
                    </a:p>
                  </a:txBody>
                  <a:tcPr marL="18001" marR="18001" marT="18006" marB="18006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0371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5</a:t>
                      </a:r>
                      <a:endParaRPr lang="en-US" sz="11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0" kern="1200" dirty="0">
                          <a:solidFill>
                            <a:srgbClr val="000000"/>
                          </a:solidFill>
                          <a:effectLst/>
                          <a:latin typeface="Segoe UI Symbol" panose="020B0502040204020203" pitchFamily="34" charset="0"/>
                          <a:ea typeface="Times New Roman" panose="02020603050405020304" pitchFamily="18" charset="0"/>
                          <a:cs typeface="Segoe UI Symbol" panose="020B0502040204020203" pitchFamily="34" charset="0"/>
                        </a:rPr>
                        <a:t>✓</a:t>
                      </a:r>
                      <a:endParaRPr lang="en-US" sz="11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x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-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-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-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-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-</a:t>
                      </a:r>
                    </a:p>
                  </a:txBody>
                  <a:tcPr marL="18001" marR="18001" marT="18006" marB="18006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-</a:t>
                      </a:r>
                    </a:p>
                  </a:txBody>
                  <a:tcPr marL="18001" marR="18001" marT="18006" marB="18006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0371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5-7</a:t>
                      </a:r>
                      <a:endParaRPr lang="en-US" sz="11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0" kern="1200" dirty="0">
                          <a:solidFill>
                            <a:srgbClr val="000000"/>
                          </a:solidFill>
                          <a:effectLst/>
                          <a:latin typeface="Segoe UI Symbol" panose="020B0502040204020203" pitchFamily="34" charset="0"/>
                          <a:ea typeface="Times New Roman" panose="02020603050405020304" pitchFamily="18" charset="0"/>
                          <a:cs typeface="Segoe UI Symbol" panose="020B0502040204020203" pitchFamily="34" charset="0"/>
                        </a:rPr>
                        <a:t>✓</a:t>
                      </a:r>
                      <a:endParaRPr lang="en-US" sz="11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x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-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-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-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-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-</a:t>
                      </a:r>
                    </a:p>
                  </a:txBody>
                  <a:tcPr marL="18001" marR="18001" marT="18006" marB="18006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-</a:t>
                      </a:r>
                    </a:p>
                  </a:txBody>
                  <a:tcPr marL="18001" marR="18001" marT="18006" marB="18006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0371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6</a:t>
                      </a:r>
                      <a:endParaRPr lang="en-US" sz="11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0" kern="1200" dirty="0">
                          <a:solidFill>
                            <a:srgbClr val="000000"/>
                          </a:solidFill>
                          <a:effectLst/>
                          <a:latin typeface="Segoe UI Symbol" panose="020B0502040204020203" pitchFamily="34" charset="0"/>
                          <a:ea typeface="Times New Roman" panose="02020603050405020304" pitchFamily="18" charset="0"/>
                          <a:cs typeface="Segoe UI Symbol" panose="020B0502040204020203" pitchFamily="34" charset="0"/>
                        </a:rPr>
                        <a:t>✓</a:t>
                      </a:r>
                      <a:endParaRPr lang="en-US" sz="11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x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-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-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-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-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-</a:t>
                      </a:r>
                    </a:p>
                  </a:txBody>
                  <a:tcPr marL="18001" marR="18001" marT="18006" marB="18006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-</a:t>
                      </a:r>
                    </a:p>
                  </a:txBody>
                  <a:tcPr marL="18001" marR="18001" marT="18006" marB="18006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0371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7</a:t>
                      </a:r>
                      <a:endParaRPr lang="en-US" sz="11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0" kern="1200" dirty="0">
                          <a:solidFill>
                            <a:srgbClr val="000000"/>
                          </a:solidFill>
                          <a:effectLst/>
                          <a:latin typeface="Segoe UI Symbol" panose="020B0502040204020203" pitchFamily="34" charset="0"/>
                          <a:ea typeface="Times New Roman" panose="02020603050405020304" pitchFamily="18" charset="0"/>
                          <a:cs typeface="Segoe UI Symbol" panose="020B0502040204020203" pitchFamily="34" charset="0"/>
                        </a:rPr>
                        <a:t>✓</a:t>
                      </a:r>
                      <a:endParaRPr lang="en-US" sz="11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0" kern="1200" dirty="0">
                          <a:solidFill>
                            <a:srgbClr val="000000"/>
                          </a:solidFill>
                          <a:effectLst/>
                          <a:latin typeface="Segoe UI Symbol" panose="020B0502040204020203" pitchFamily="34" charset="0"/>
                          <a:ea typeface="Times New Roman" panose="02020603050405020304" pitchFamily="18" charset="0"/>
                          <a:cs typeface="Segoe UI Symbol" panose="020B0502040204020203" pitchFamily="34" charset="0"/>
                        </a:rPr>
                        <a:t>✓</a:t>
                      </a:r>
                      <a:endParaRPr lang="en-US" sz="11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0" kern="1200" dirty="0">
                          <a:solidFill>
                            <a:srgbClr val="000000"/>
                          </a:solidFill>
                          <a:effectLst/>
                          <a:latin typeface="Segoe UI Symbol" panose="020B0502040204020203" pitchFamily="34" charset="0"/>
                          <a:ea typeface="Times New Roman" panose="02020603050405020304" pitchFamily="18" charset="0"/>
                          <a:cs typeface="Segoe UI Symbol" panose="020B0502040204020203" pitchFamily="34" charset="0"/>
                        </a:rPr>
                        <a:t>✓</a:t>
                      </a:r>
                      <a:endParaRPr lang="en-US" sz="11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0" kern="1200" dirty="0">
                          <a:solidFill>
                            <a:srgbClr val="000000"/>
                          </a:solidFill>
                          <a:effectLst/>
                          <a:latin typeface="Segoe UI Symbol" panose="020B0502040204020203" pitchFamily="34" charset="0"/>
                          <a:ea typeface="Times New Roman" panose="02020603050405020304" pitchFamily="18" charset="0"/>
                          <a:cs typeface="Segoe UI Symbol" panose="020B0502040204020203" pitchFamily="34" charset="0"/>
                        </a:rPr>
                        <a:t>✓</a:t>
                      </a:r>
                      <a:endParaRPr lang="en-US" sz="11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x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-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1" marR="18001" marT="18006" marB="18006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-</a:t>
                      </a:r>
                    </a:p>
                  </a:txBody>
                  <a:tcPr marL="18001" marR="18001" marT="18006" marB="18006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-</a:t>
                      </a:r>
                    </a:p>
                  </a:txBody>
                  <a:tcPr marL="18001" marR="18001" marT="18006" marB="18006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03712">
                <a:tc gridSpan="9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s-ES" sz="1400" b="0" baseline="30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</a:t>
                      </a:r>
                      <a:r>
                        <a:rPr lang="en-001" sz="1100" b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On</a:t>
                      </a:r>
                      <a:r>
                        <a:rPr lang="en-GB" sz="1100" b="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y</a:t>
                      </a:r>
                      <a:r>
                        <a:rPr lang="en-GB" sz="11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d</a:t>
                      </a:r>
                      <a:r>
                        <a:rPr lang="en-001" sz="1100" b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</a:t>
                      </a:r>
                      <a:r>
                        <a:rPr lang="en-GB" sz="11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</a:t>
                      </a:r>
                      <a:r>
                        <a:rPr lang="en-001" sz="1100" b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</a:t>
                      </a:r>
                      <a:r>
                        <a:rPr lang="en-GB" sz="1100" b="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001" sz="1100" b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GB" sz="11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</a:t>
                      </a:r>
                      <a:r>
                        <a:rPr lang="en-001" sz="1100" b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1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–4 </a:t>
                      </a:r>
                      <a:r>
                        <a:rPr lang="en-001" sz="1100" b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</a:t>
                      </a:r>
                      <a:r>
                        <a:rPr lang="en-GB" sz="11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</a:t>
                      </a:r>
                      <a:r>
                        <a:rPr lang="en-001" sz="1100" b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lang="en-GB" sz="11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</a:t>
                      </a:r>
                      <a:r>
                        <a:rPr lang="en-001" sz="1100" b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1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lang="en-001" sz="1100" b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</a:t>
                      </a:r>
                      <a:r>
                        <a:rPr lang="en-GB" sz="11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</a:t>
                      </a:r>
                      <a:r>
                        <a:rPr lang="en-001" sz="1100" b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</a:t>
                      </a:r>
                      <a:r>
                        <a:rPr lang="en-GB" sz="11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</a:t>
                      </a:r>
                      <a:r>
                        <a:rPr lang="en-001" sz="1100" b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v</a:t>
                      </a:r>
                      <a:r>
                        <a:rPr lang="en-GB" sz="11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</a:t>
                      </a:r>
                      <a:r>
                        <a:rPr lang="en-001" sz="1100" b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 </a:t>
                      </a:r>
                      <a:r>
                        <a:rPr lang="en-GB" sz="1100" b="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001" sz="1100" b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 </a:t>
                      </a:r>
                      <a:r>
                        <a:rPr lang="es-ES" sz="1100" b="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he</a:t>
                      </a:r>
                      <a:r>
                        <a:rPr lang="en-001" sz="1100" b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PA</a:t>
                      </a:r>
                      <a:r>
                        <a:rPr lang="en-001" sz="1100" b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100" b="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ap</a:t>
                      </a:r>
                      <a:r>
                        <a:rPr lang="en-GB" sz="11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.</a:t>
                      </a:r>
                      <a:endParaRPr lang="en-US" sz="11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8001" marR="18001" marT="18006" marB="1800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US" sz="11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0" marR="18000" marT="18000" marB="18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0" marR="18000" marT="18000" marB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0" marR="18000" marT="18000" marB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0" marR="18000" marT="18000" marB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0" marR="18000" marT="18000" marB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0" marR="18000" marT="18000" marB="1800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0" marR="18000" marT="18000" marB="18000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8000" marR="18000" marT="18000" marB="18000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3076</TotalTime>
  <Words>157</Words>
  <Application>Microsoft Macintosh PowerPoint</Application>
  <PresentationFormat>A4 Paper (210x297 mm)</PresentationFormat>
  <Paragraphs>1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Calibri</vt:lpstr>
      <vt:lpstr>Arial</vt:lpstr>
      <vt:lpstr>Calibri Light</vt:lpstr>
      <vt:lpstr>Times New Roman</vt:lpstr>
      <vt:lpstr>Segoe UI 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.X.Gomis-Rüth</dc:creator>
  <cp:lastModifiedBy>F.X.Gomis-Rüth</cp:lastModifiedBy>
  <cp:revision>406</cp:revision>
  <dcterms:created xsi:type="dcterms:W3CDTF">2024-01-16T16:15:53Z</dcterms:created>
  <dcterms:modified xsi:type="dcterms:W3CDTF">2025-06-18T09:53:43Z</dcterms:modified>
</cp:coreProperties>
</file>